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53" y="9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196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28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720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169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647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49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80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07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034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590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44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890E3F-2249-40A5-BC71-98F25A885F55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59DB6-B030-4B00-8138-CB70127C3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057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628333"/>
            <a:ext cx="9713912" cy="5223827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389467" y="5722034"/>
            <a:ext cx="11667067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9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normalized-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nM) for quinolines against sensitive strain D10. There were three compounds (with hydro-, hydroxyl-, and acetyl- radicals at 7- position) were removed from this analysis, because they had very weak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ranging from 448 to 3017 nM) and non-detectable anti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ozo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.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2938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0:11Z</dcterms:created>
  <dcterms:modified xsi:type="dcterms:W3CDTF">2020-08-04T16:34:59Z</dcterms:modified>
</cp:coreProperties>
</file>